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9477715-C635-4198-BADD-8F1A60D9331C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58174DE-3DB8-4B97-887B-99C33C47E801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4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umbers are Log2 ratio of infected to uninfected wound gene expression.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48988DE-DE35-43D9-B411-A52C36261DB7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5FF76A-A40E-4B23-BAB2-C13161DC099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278BF9-3723-4C2E-A243-A142A9B7187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653226-8227-4B18-907E-3C4C4154089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8771E3-C64D-4A8F-93B3-0EAF95067ED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5BFE70-FFA7-49C1-92F6-9518D74D4D1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DB0705-FBB3-4797-B5F1-9227F38E425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F7B5D6-C743-4FB1-AB2C-4FC497D6249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EC0F06-E72E-4F49-BB2B-9907AE4A56D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14E2CE-CDB1-484C-9B40-936E1462C9B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647F87-894B-4DBB-A898-C10B956CBB2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F21D20-C9C9-4E49-8A11-B09E32401F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9AA309-4A45-4888-ADEF-44F15330FD2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F4B2BBB-5FD5-46F1-97D8-2D41DCCB362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3"/>
          <p:cNvSpPr/>
          <p:nvPr/>
        </p:nvSpPr>
        <p:spPr>
          <a:xfrm>
            <a:off x="2971800" y="1752480"/>
            <a:ext cx="25909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480" rIns="6480" tIns="6480" bIns="0" anchor="b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upplementary Table 1.</a:t>
            </a: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RT-qPCR Validation of Microarray Gene Express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9" name="Group 694"/>
          <p:cNvGrpSpPr/>
          <p:nvPr/>
        </p:nvGrpSpPr>
        <p:grpSpPr>
          <a:xfrm>
            <a:off x="3048120" y="2057400"/>
            <a:ext cx="2033640" cy="2081160"/>
            <a:chOff x="3048120" y="2057400"/>
            <a:chExt cx="2033640" cy="2081160"/>
          </a:xfrm>
        </p:grpSpPr>
        <p:sp>
          <p:nvSpPr>
            <p:cNvPr id="50" name="Rectangle 596"/>
            <p:cNvSpPr/>
            <p:nvPr/>
          </p:nvSpPr>
          <p:spPr>
            <a:xfrm>
              <a:off x="3048120" y="2325600"/>
              <a:ext cx="2031840" cy="139680"/>
            </a:xfrm>
            <a:prstGeom prst="rect">
              <a:avLst/>
            </a:prstGeom>
            <a:solidFill>
              <a:srgbClr val="b8cce4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b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OD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565"/>
            <p:cNvSpPr/>
            <p:nvPr/>
          </p:nvSpPr>
          <p:spPr>
            <a:xfrm>
              <a:off x="3048120" y="3294000"/>
              <a:ext cx="2031840" cy="139680"/>
            </a:xfrm>
            <a:prstGeom prst="rect">
              <a:avLst/>
            </a:prstGeom>
            <a:solidFill>
              <a:srgbClr val="b8cce4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b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POD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542"/>
            <p:cNvSpPr/>
            <p:nvPr/>
          </p:nvSpPr>
          <p:spPr>
            <a:xfrm>
              <a:off x="4673880" y="3433680"/>
              <a:ext cx="406080" cy="139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 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.5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Rectangle 540"/>
            <p:cNvSpPr/>
            <p:nvPr/>
          </p:nvSpPr>
          <p:spPr>
            <a:xfrm>
              <a:off x="4267440" y="3433680"/>
              <a:ext cx="406440" cy="139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Rectangle 538"/>
            <p:cNvSpPr/>
            <p:nvPr/>
          </p:nvSpPr>
          <p:spPr>
            <a:xfrm>
              <a:off x="3861000" y="3433680"/>
              <a:ext cx="406440" cy="139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 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.0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Rectangle 536"/>
            <p:cNvSpPr/>
            <p:nvPr/>
          </p:nvSpPr>
          <p:spPr>
            <a:xfrm>
              <a:off x="3454560" y="3433680"/>
              <a:ext cx="406440" cy="139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.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Rectangle 534"/>
            <p:cNvSpPr/>
            <p:nvPr/>
          </p:nvSpPr>
          <p:spPr>
            <a:xfrm>
              <a:off x="3048120" y="3433680"/>
              <a:ext cx="406440" cy="139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b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FIT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Rectangle 503"/>
            <p:cNvSpPr/>
            <p:nvPr/>
          </p:nvSpPr>
          <p:spPr>
            <a:xfrm>
              <a:off x="3048120" y="3573360"/>
              <a:ext cx="2031840" cy="139680"/>
            </a:xfrm>
            <a:prstGeom prst="rect">
              <a:avLst/>
            </a:prstGeom>
            <a:solidFill>
              <a:srgbClr val="b8cce4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b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POD1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Rectangle 480"/>
            <p:cNvSpPr/>
            <p:nvPr/>
          </p:nvSpPr>
          <p:spPr>
            <a:xfrm>
              <a:off x="4673880" y="3713040"/>
              <a:ext cx="406080" cy="139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 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1.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Rectangle 478"/>
            <p:cNvSpPr/>
            <p:nvPr/>
          </p:nvSpPr>
          <p:spPr>
            <a:xfrm>
              <a:off x="4267440" y="3713040"/>
              <a:ext cx="406440" cy="139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1.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Rectangle 476"/>
            <p:cNvSpPr/>
            <p:nvPr/>
          </p:nvSpPr>
          <p:spPr>
            <a:xfrm>
              <a:off x="3861000" y="3713040"/>
              <a:ext cx="406440" cy="139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 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2.2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Rectangle 474"/>
            <p:cNvSpPr/>
            <p:nvPr/>
          </p:nvSpPr>
          <p:spPr>
            <a:xfrm>
              <a:off x="3454560" y="3713040"/>
              <a:ext cx="406440" cy="139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2.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Rectangle 472"/>
            <p:cNvSpPr/>
            <p:nvPr/>
          </p:nvSpPr>
          <p:spPr>
            <a:xfrm>
              <a:off x="3048120" y="3713040"/>
              <a:ext cx="406440" cy="139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b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THBS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Rectangle 449"/>
            <p:cNvSpPr/>
            <p:nvPr/>
          </p:nvSpPr>
          <p:spPr>
            <a:xfrm>
              <a:off x="4673880" y="3852720"/>
              <a:ext cx="406080" cy="139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1.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Rectangle 447"/>
            <p:cNvSpPr/>
            <p:nvPr/>
          </p:nvSpPr>
          <p:spPr>
            <a:xfrm>
              <a:off x="4267440" y="3852720"/>
              <a:ext cx="406440" cy="139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Rectangle 445"/>
            <p:cNvSpPr/>
            <p:nvPr/>
          </p:nvSpPr>
          <p:spPr>
            <a:xfrm>
              <a:off x="3861000" y="3852720"/>
              <a:ext cx="406440" cy="139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 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1.8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Rectangle 443"/>
            <p:cNvSpPr/>
            <p:nvPr/>
          </p:nvSpPr>
          <p:spPr>
            <a:xfrm>
              <a:off x="3454560" y="3852720"/>
              <a:ext cx="406440" cy="139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1.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Rectangle 441"/>
            <p:cNvSpPr/>
            <p:nvPr/>
          </p:nvSpPr>
          <p:spPr>
            <a:xfrm>
              <a:off x="3048120" y="3852720"/>
              <a:ext cx="406440" cy="139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b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OL5A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Rectangle 418"/>
            <p:cNvSpPr/>
            <p:nvPr/>
          </p:nvSpPr>
          <p:spPr>
            <a:xfrm>
              <a:off x="4673880" y="3992400"/>
              <a:ext cx="406080" cy="139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 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1.0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Rectangle 416"/>
            <p:cNvSpPr/>
            <p:nvPr/>
          </p:nvSpPr>
          <p:spPr>
            <a:xfrm>
              <a:off x="4267440" y="3992400"/>
              <a:ext cx="406440" cy="139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1.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Rectangle 414"/>
            <p:cNvSpPr/>
            <p:nvPr/>
          </p:nvSpPr>
          <p:spPr>
            <a:xfrm>
              <a:off x="3861000" y="3992400"/>
              <a:ext cx="406440" cy="139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 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1.4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Rectangle 412"/>
            <p:cNvSpPr/>
            <p:nvPr/>
          </p:nvSpPr>
          <p:spPr>
            <a:xfrm>
              <a:off x="3454560" y="3992400"/>
              <a:ext cx="406440" cy="139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1.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Rectangle 410"/>
            <p:cNvSpPr/>
            <p:nvPr/>
          </p:nvSpPr>
          <p:spPr>
            <a:xfrm>
              <a:off x="3048120" y="3992400"/>
              <a:ext cx="406440" cy="139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b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LOXL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Rectangle 354"/>
            <p:cNvSpPr/>
            <p:nvPr/>
          </p:nvSpPr>
          <p:spPr>
            <a:xfrm>
              <a:off x="4673880" y="3154320"/>
              <a:ext cx="406080" cy="139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 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.0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Rectangle 352"/>
            <p:cNvSpPr/>
            <p:nvPr/>
          </p:nvSpPr>
          <p:spPr>
            <a:xfrm>
              <a:off x="4267440" y="3154320"/>
              <a:ext cx="406440" cy="139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.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Rectangle 350"/>
            <p:cNvSpPr/>
            <p:nvPr/>
          </p:nvSpPr>
          <p:spPr>
            <a:xfrm>
              <a:off x="3861000" y="3154320"/>
              <a:ext cx="406440" cy="139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 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.0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Rectangle 348"/>
            <p:cNvSpPr/>
            <p:nvPr/>
          </p:nvSpPr>
          <p:spPr>
            <a:xfrm>
              <a:off x="3454560" y="3154320"/>
              <a:ext cx="406440" cy="139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.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Rectangle 346"/>
            <p:cNvSpPr/>
            <p:nvPr/>
          </p:nvSpPr>
          <p:spPr>
            <a:xfrm>
              <a:off x="3048120" y="3154320"/>
              <a:ext cx="406440" cy="139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b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L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Rectangle 7"/>
            <p:cNvSpPr/>
            <p:nvPr/>
          </p:nvSpPr>
          <p:spPr>
            <a:xfrm>
              <a:off x="3048120" y="2057400"/>
              <a:ext cx="406440" cy="268200"/>
            </a:xfrm>
            <a:prstGeom prst="rect">
              <a:avLst/>
            </a:prstGeom>
            <a:solidFill>
              <a:srgbClr val="b8cce4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b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Gene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Rectangle 8"/>
            <p:cNvSpPr/>
            <p:nvPr/>
          </p:nvSpPr>
          <p:spPr>
            <a:xfrm>
              <a:off x="3454560" y="2057400"/>
              <a:ext cx="812880" cy="139680"/>
            </a:xfrm>
            <a:prstGeom prst="rect">
              <a:avLst/>
            </a:prstGeom>
            <a:solidFill>
              <a:srgbClr val="b8cce4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b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K.p.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Rectangle 9"/>
            <p:cNvSpPr/>
            <p:nvPr/>
          </p:nvSpPr>
          <p:spPr>
            <a:xfrm>
              <a:off x="4267440" y="2057400"/>
              <a:ext cx="812520" cy="139680"/>
            </a:xfrm>
            <a:prstGeom prst="rect">
              <a:avLst/>
            </a:prstGeom>
            <a:solidFill>
              <a:srgbClr val="b8cce4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b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.a.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Rectangle 16"/>
            <p:cNvSpPr/>
            <p:nvPr/>
          </p:nvSpPr>
          <p:spPr>
            <a:xfrm>
              <a:off x="3454560" y="2197080"/>
              <a:ext cx="406440" cy="128520"/>
            </a:xfrm>
            <a:prstGeom prst="rect">
              <a:avLst/>
            </a:prstGeom>
            <a:solidFill>
              <a:srgbClr val="b8cce4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rray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Rectangle 17"/>
            <p:cNvSpPr/>
            <p:nvPr/>
          </p:nvSpPr>
          <p:spPr>
            <a:xfrm>
              <a:off x="3861000" y="2197080"/>
              <a:ext cx="406440" cy="128520"/>
            </a:xfrm>
            <a:prstGeom prst="rect">
              <a:avLst/>
            </a:prstGeom>
            <a:solidFill>
              <a:srgbClr val="b8cce4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C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Rectangle 18"/>
            <p:cNvSpPr/>
            <p:nvPr/>
          </p:nvSpPr>
          <p:spPr>
            <a:xfrm>
              <a:off x="4267440" y="2197080"/>
              <a:ext cx="406440" cy="128520"/>
            </a:xfrm>
            <a:prstGeom prst="rect">
              <a:avLst/>
            </a:prstGeom>
            <a:solidFill>
              <a:srgbClr val="b8cce4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rray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Rectangle 19"/>
            <p:cNvSpPr/>
            <p:nvPr/>
          </p:nvSpPr>
          <p:spPr>
            <a:xfrm>
              <a:off x="4673880" y="2197080"/>
              <a:ext cx="406080" cy="128520"/>
            </a:xfrm>
            <a:prstGeom prst="rect">
              <a:avLst/>
            </a:prstGeom>
            <a:solidFill>
              <a:srgbClr val="b8cce4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C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Rectangle 28"/>
            <p:cNvSpPr/>
            <p:nvPr/>
          </p:nvSpPr>
          <p:spPr>
            <a:xfrm>
              <a:off x="3048120" y="2465280"/>
              <a:ext cx="406440" cy="139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b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L23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Rectangle 29"/>
            <p:cNvSpPr/>
            <p:nvPr/>
          </p:nvSpPr>
          <p:spPr>
            <a:xfrm>
              <a:off x="3454560" y="2465280"/>
              <a:ext cx="406440" cy="139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*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Rectangle 30"/>
            <p:cNvSpPr/>
            <p:nvPr/>
          </p:nvSpPr>
          <p:spPr>
            <a:xfrm>
              <a:off x="3861000" y="2465280"/>
              <a:ext cx="406440" cy="139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.60 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Rectangle 31"/>
            <p:cNvSpPr/>
            <p:nvPr/>
          </p:nvSpPr>
          <p:spPr>
            <a:xfrm>
              <a:off x="4267440" y="2465280"/>
              <a:ext cx="406440" cy="139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Rectangle 32"/>
            <p:cNvSpPr/>
            <p:nvPr/>
          </p:nvSpPr>
          <p:spPr>
            <a:xfrm>
              <a:off x="4673880" y="2465280"/>
              <a:ext cx="406080" cy="139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.29 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Rectangle 43"/>
            <p:cNvSpPr/>
            <p:nvPr/>
          </p:nvSpPr>
          <p:spPr>
            <a:xfrm>
              <a:off x="3048120" y="2604960"/>
              <a:ext cx="406440" cy="14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b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L1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Rectangle 44"/>
            <p:cNvSpPr/>
            <p:nvPr/>
          </p:nvSpPr>
          <p:spPr>
            <a:xfrm>
              <a:off x="3454560" y="2604960"/>
              <a:ext cx="406440" cy="14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Rectangle 45"/>
            <p:cNvSpPr/>
            <p:nvPr/>
          </p:nvSpPr>
          <p:spPr>
            <a:xfrm>
              <a:off x="3861000" y="2604960"/>
              <a:ext cx="406440" cy="14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 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.2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Rectangle 46"/>
            <p:cNvSpPr/>
            <p:nvPr/>
          </p:nvSpPr>
          <p:spPr>
            <a:xfrm>
              <a:off x="4267440" y="2604960"/>
              <a:ext cx="406440" cy="14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Rectangle 47"/>
            <p:cNvSpPr/>
            <p:nvPr/>
          </p:nvSpPr>
          <p:spPr>
            <a:xfrm>
              <a:off x="4673880" y="2604960"/>
              <a:ext cx="406080" cy="14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 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.4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Rectangle 58"/>
            <p:cNvSpPr/>
            <p:nvPr/>
          </p:nvSpPr>
          <p:spPr>
            <a:xfrm>
              <a:off x="3048120" y="2746080"/>
              <a:ext cx="406440" cy="140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b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KBK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Rectangle 59"/>
            <p:cNvSpPr/>
            <p:nvPr/>
          </p:nvSpPr>
          <p:spPr>
            <a:xfrm>
              <a:off x="3454560" y="2746080"/>
              <a:ext cx="406440" cy="140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Rectangle 60"/>
            <p:cNvSpPr/>
            <p:nvPr/>
          </p:nvSpPr>
          <p:spPr>
            <a:xfrm>
              <a:off x="3861000" y="2746080"/>
              <a:ext cx="406440" cy="140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 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.1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Rectangle 61"/>
            <p:cNvSpPr/>
            <p:nvPr/>
          </p:nvSpPr>
          <p:spPr>
            <a:xfrm>
              <a:off x="4267440" y="2746080"/>
              <a:ext cx="406440" cy="140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.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Rectangle 62"/>
            <p:cNvSpPr/>
            <p:nvPr/>
          </p:nvSpPr>
          <p:spPr>
            <a:xfrm>
              <a:off x="4673880" y="2746080"/>
              <a:ext cx="406080" cy="140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 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.1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Rectangle 73"/>
            <p:cNvSpPr/>
            <p:nvPr/>
          </p:nvSpPr>
          <p:spPr>
            <a:xfrm>
              <a:off x="3048120" y="2886120"/>
              <a:ext cx="406440" cy="12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b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FKB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Rectangle 74"/>
            <p:cNvSpPr/>
            <p:nvPr/>
          </p:nvSpPr>
          <p:spPr>
            <a:xfrm>
              <a:off x="3454560" y="2886120"/>
              <a:ext cx="406440" cy="12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.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Rectangle 75"/>
            <p:cNvSpPr/>
            <p:nvPr/>
          </p:nvSpPr>
          <p:spPr>
            <a:xfrm>
              <a:off x="3861000" y="2886120"/>
              <a:ext cx="406440" cy="12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 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.2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Rectangle 76"/>
            <p:cNvSpPr/>
            <p:nvPr/>
          </p:nvSpPr>
          <p:spPr>
            <a:xfrm>
              <a:off x="4267440" y="2886120"/>
              <a:ext cx="406440" cy="12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.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Rectangle 77"/>
            <p:cNvSpPr/>
            <p:nvPr/>
          </p:nvSpPr>
          <p:spPr>
            <a:xfrm>
              <a:off x="4673880" y="2886120"/>
              <a:ext cx="406080" cy="12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.4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Rectangle 88"/>
            <p:cNvSpPr/>
            <p:nvPr/>
          </p:nvSpPr>
          <p:spPr>
            <a:xfrm>
              <a:off x="3048120" y="3014640"/>
              <a:ext cx="406440" cy="139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b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XCL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Rectangle 89"/>
            <p:cNvSpPr/>
            <p:nvPr/>
          </p:nvSpPr>
          <p:spPr>
            <a:xfrm>
              <a:off x="3454560" y="3014640"/>
              <a:ext cx="406440" cy="139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.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Rectangle 90"/>
            <p:cNvSpPr/>
            <p:nvPr/>
          </p:nvSpPr>
          <p:spPr>
            <a:xfrm>
              <a:off x="3861000" y="3014640"/>
              <a:ext cx="406440" cy="139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 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.4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Rectangle 91"/>
            <p:cNvSpPr/>
            <p:nvPr/>
          </p:nvSpPr>
          <p:spPr>
            <a:xfrm>
              <a:off x="4267440" y="3014640"/>
              <a:ext cx="406440" cy="139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.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Rectangle 92"/>
            <p:cNvSpPr/>
            <p:nvPr/>
          </p:nvSpPr>
          <p:spPr>
            <a:xfrm>
              <a:off x="4673880" y="3014640"/>
              <a:ext cx="406080" cy="139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80" rIns="6480" tIns="6480" bIns="0" anchor="t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 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.7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Line 118"/>
            <p:cNvSpPr/>
            <p:nvPr/>
          </p:nvSpPr>
          <p:spPr>
            <a:xfrm>
              <a:off x="3454560" y="2057400"/>
              <a:ext cx="0" cy="2682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Line 119"/>
            <p:cNvSpPr/>
            <p:nvPr/>
          </p:nvSpPr>
          <p:spPr>
            <a:xfrm>
              <a:off x="3861000" y="2197080"/>
              <a:ext cx="0" cy="128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Line 120"/>
            <p:cNvSpPr/>
            <p:nvPr/>
          </p:nvSpPr>
          <p:spPr>
            <a:xfrm>
              <a:off x="4267440" y="2057400"/>
              <a:ext cx="0" cy="2682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Line 121"/>
            <p:cNvSpPr/>
            <p:nvPr/>
          </p:nvSpPr>
          <p:spPr>
            <a:xfrm>
              <a:off x="4673880" y="2197080"/>
              <a:ext cx="0" cy="128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Line 134"/>
            <p:cNvSpPr/>
            <p:nvPr/>
          </p:nvSpPr>
          <p:spPr>
            <a:xfrm>
              <a:off x="3454560" y="2197080"/>
              <a:ext cx="16254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Line 137"/>
            <p:cNvSpPr/>
            <p:nvPr/>
          </p:nvSpPr>
          <p:spPr>
            <a:xfrm>
              <a:off x="3048120" y="2325600"/>
              <a:ext cx="2031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Line 138"/>
            <p:cNvSpPr/>
            <p:nvPr/>
          </p:nvSpPr>
          <p:spPr>
            <a:xfrm>
              <a:off x="3048120" y="2604960"/>
              <a:ext cx="2031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Line 139"/>
            <p:cNvSpPr/>
            <p:nvPr/>
          </p:nvSpPr>
          <p:spPr>
            <a:xfrm>
              <a:off x="3048120" y="2746080"/>
              <a:ext cx="2031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Line 140"/>
            <p:cNvSpPr/>
            <p:nvPr/>
          </p:nvSpPr>
          <p:spPr>
            <a:xfrm>
              <a:off x="3048120" y="2886120"/>
              <a:ext cx="2031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Line 141"/>
            <p:cNvSpPr/>
            <p:nvPr/>
          </p:nvSpPr>
          <p:spPr>
            <a:xfrm>
              <a:off x="3048120" y="3014640"/>
              <a:ext cx="2031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Line 142"/>
            <p:cNvSpPr/>
            <p:nvPr/>
          </p:nvSpPr>
          <p:spPr>
            <a:xfrm>
              <a:off x="3048120" y="3154320"/>
              <a:ext cx="2031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Line 143"/>
            <p:cNvSpPr/>
            <p:nvPr/>
          </p:nvSpPr>
          <p:spPr>
            <a:xfrm>
              <a:off x="3048120" y="2057400"/>
              <a:ext cx="0" cy="207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Line 144"/>
            <p:cNvSpPr/>
            <p:nvPr/>
          </p:nvSpPr>
          <p:spPr>
            <a:xfrm>
              <a:off x="5081760" y="2057400"/>
              <a:ext cx="0" cy="207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Line 347"/>
            <p:cNvSpPr/>
            <p:nvPr/>
          </p:nvSpPr>
          <p:spPr>
            <a:xfrm>
              <a:off x="3048120" y="3294000"/>
              <a:ext cx="2031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Line 442"/>
            <p:cNvSpPr/>
            <p:nvPr/>
          </p:nvSpPr>
          <p:spPr>
            <a:xfrm>
              <a:off x="3048120" y="3992400"/>
              <a:ext cx="2031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Line 473"/>
            <p:cNvSpPr/>
            <p:nvPr/>
          </p:nvSpPr>
          <p:spPr>
            <a:xfrm>
              <a:off x="3048120" y="3852720"/>
              <a:ext cx="2031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Line 504"/>
            <p:cNvSpPr/>
            <p:nvPr/>
          </p:nvSpPr>
          <p:spPr>
            <a:xfrm>
              <a:off x="3048120" y="3713040"/>
              <a:ext cx="2031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Line 535"/>
            <p:cNvSpPr/>
            <p:nvPr/>
          </p:nvSpPr>
          <p:spPr>
            <a:xfrm>
              <a:off x="3048120" y="3573360"/>
              <a:ext cx="2031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Line 566"/>
            <p:cNvSpPr/>
            <p:nvPr/>
          </p:nvSpPr>
          <p:spPr>
            <a:xfrm>
              <a:off x="3048120" y="3433680"/>
              <a:ext cx="2031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Line 597"/>
            <p:cNvSpPr/>
            <p:nvPr/>
          </p:nvSpPr>
          <p:spPr>
            <a:xfrm>
              <a:off x="3048120" y="2465280"/>
              <a:ext cx="2031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Line 627"/>
            <p:cNvSpPr/>
            <p:nvPr/>
          </p:nvSpPr>
          <p:spPr>
            <a:xfrm>
              <a:off x="3454560" y="2465280"/>
              <a:ext cx="0" cy="828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Line 629"/>
            <p:cNvSpPr/>
            <p:nvPr/>
          </p:nvSpPr>
          <p:spPr>
            <a:xfrm>
              <a:off x="3861000" y="2465280"/>
              <a:ext cx="0" cy="828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Line 631"/>
            <p:cNvSpPr/>
            <p:nvPr/>
          </p:nvSpPr>
          <p:spPr>
            <a:xfrm>
              <a:off x="4267440" y="2465280"/>
              <a:ext cx="0" cy="828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Line 633"/>
            <p:cNvSpPr/>
            <p:nvPr/>
          </p:nvSpPr>
          <p:spPr>
            <a:xfrm>
              <a:off x="4673880" y="2465280"/>
              <a:ext cx="0" cy="828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Line 638"/>
            <p:cNvSpPr/>
            <p:nvPr/>
          </p:nvSpPr>
          <p:spPr>
            <a:xfrm>
              <a:off x="3454560" y="3433680"/>
              <a:ext cx="0" cy="139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Line 640"/>
            <p:cNvSpPr/>
            <p:nvPr/>
          </p:nvSpPr>
          <p:spPr>
            <a:xfrm>
              <a:off x="3861000" y="3433680"/>
              <a:ext cx="0" cy="139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Line 642"/>
            <p:cNvSpPr/>
            <p:nvPr/>
          </p:nvSpPr>
          <p:spPr>
            <a:xfrm>
              <a:off x="4267440" y="3433680"/>
              <a:ext cx="0" cy="139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Line 644"/>
            <p:cNvSpPr/>
            <p:nvPr/>
          </p:nvSpPr>
          <p:spPr>
            <a:xfrm>
              <a:off x="4673880" y="3433680"/>
              <a:ext cx="0" cy="139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Line 656"/>
            <p:cNvSpPr/>
            <p:nvPr/>
          </p:nvSpPr>
          <p:spPr>
            <a:xfrm>
              <a:off x="3454560" y="3713040"/>
              <a:ext cx="0" cy="419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Line 658"/>
            <p:cNvSpPr/>
            <p:nvPr/>
          </p:nvSpPr>
          <p:spPr>
            <a:xfrm>
              <a:off x="3861000" y="3713040"/>
              <a:ext cx="0" cy="419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Line 660"/>
            <p:cNvSpPr/>
            <p:nvPr/>
          </p:nvSpPr>
          <p:spPr>
            <a:xfrm>
              <a:off x="4267440" y="3713040"/>
              <a:ext cx="0" cy="419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Line 662"/>
            <p:cNvSpPr/>
            <p:nvPr/>
          </p:nvSpPr>
          <p:spPr>
            <a:xfrm>
              <a:off x="4673880" y="3713040"/>
              <a:ext cx="0" cy="419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Line 692"/>
            <p:cNvSpPr/>
            <p:nvPr/>
          </p:nvSpPr>
          <p:spPr>
            <a:xfrm>
              <a:off x="3048120" y="2057400"/>
              <a:ext cx="2031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Line 693"/>
            <p:cNvSpPr/>
            <p:nvPr/>
          </p:nvSpPr>
          <p:spPr>
            <a:xfrm>
              <a:off x="3048120" y="4138560"/>
              <a:ext cx="2031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44" name="TextBox 99"/>
          <p:cNvSpPr/>
          <p:nvPr/>
        </p:nvSpPr>
        <p:spPr>
          <a:xfrm>
            <a:off x="2914920" y="4191120"/>
            <a:ext cx="4301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*Numbers are Log2 ratio of infected to uninfected wound gene express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9-17T16:13:50Z</dcterms:created>
  <dc:creator>sjh368</dc:creator>
  <dc:description/>
  <cp:keywords>Supp_table_1_9-17-13_simple Supp_Table_1_Leung</cp:keywords>
  <dc:language>en-US</dc:language>
  <cp:lastModifiedBy>Kai.Leung</cp:lastModifiedBy>
  <dcterms:modified xsi:type="dcterms:W3CDTF">2013-09-17T19:55:29Z</dcterms:modified>
  <cp:revision>11</cp:revision>
  <dc:subject/>
  <dc:title>Slide 1</dc:title>
</cp:coreProperties>
</file>